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1" r:id="rId2"/>
    <p:sldId id="288" r:id="rId3"/>
    <p:sldId id="273" r:id="rId4"/>
    <p:sldId id="259" r:id="rId5"/>
    <p:sldId id="283" r:id="rId6"/>
    <p:sldId id="289" r:id="rId7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BFF"/>
    <a:srgbClr val="6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79" autoAdjust="0"/>
    <p:restoredTop sz="86408"/>
  </p:normalViewPr>
  <p:slideViewPr>
    <p:cSldViewPr snapToGrid="0">
      <p:cViewPr varScale="1">
        <p:scale>
          <a:sx n="106" d="100"/>
          <a:sy n="106" d="100"/>
        </p:scale>
        <p:origin x="1232" y="168"/>
      </p:cViewPr>
      <p:guideLst/>
    </p:cSldViewPr>
  </p:slideViewPr>
  <p:outlineViewPr>
    <p:cViewPr>
      <p:scale>
        <a:sx n="33" d="100"/>
        <a:sy n="33" d="100"/>
      </p:scale>
      <p:origin x="0" y="0"/>
    </p:cViewPr>
    <p:sldLst>
      <p:sld r:id="rId1" collapse="1"/>
    </p:sldLst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4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L" dirty="0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F71C5A-C83F-42C8-BB0D-B3333C59BF99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L" dirty="0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L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7F44F7-89CF-4225-9746-17AFDE9F6DC2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3288432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F44F7-89CF-4225-9746-17AFDE9F6DC2}" type="slidenum">
              <a:rPr lang="es-CL" smtClean="0"/>
              <a:t>1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7591249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F44F7-89CF-4225-9746-17AFDE9F6DC2}" type="slidenum">
              <a:rPr lang="es-CL" smtClean="0"/>
              <a:t>2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22602510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F44F7-89CF-4225-9746-17AFDE9F6DC2}" type="slidenum">
              <a:rPr lang="es-CL" smtClean="0"/>
              <a:t>3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40240441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F44F7-89CF-4225-9746-17AFDE9F6DC2}" type="slidenum">
              <a:rPr lang="es-CL" smtClean="0"/>
              <a:t>4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99833836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F44F7-89CF-4225-9746-17AFDE9F6DC2}" type="slidenum">
              <a:rPr lang="es-CL" smtClean="0"/>
              <a:t>5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387277382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FF06FF9-131B-AA06-3511-49F75A0A51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EAA5E18-A9ED-3F38-CB0B-5440879F14C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7725FAE-878F-1F29-066C-AB25B537E6E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F33514-5912-595C-CCB1-BAE388A2F61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7F44F7-89CF-4225-9746-17AFDE9F6DC2}" type="slidenum">
              <a:rPr lang="es-CL" smtClean="0"/>
              <a:t>6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4058906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15E39A6-2199-5552-651F-AC63E67477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417FF08-271F-0DFA-BC25-F50C278602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B139FE2-8907-C332-D851-A0918E2FD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E602A12-5565-7FD3-8572-7A1EF926D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8F8B68D-FDF0-E1DC-D191-BD21B9C92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3177379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D668675-E2DA-DA40-BB98-DF188082AC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FBF0955-98FF-9809-15A1-27F846D7FB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6AA2975-4CC4-C3A9-1F9F-B1E4D2823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1DC7CD8-8ACB-90A8-3A34-DC0E70EFE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977A5E7-E526-F2F4-4345-26D4FE5EA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746533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AEC7EB8-047F-D3E9-DA88-110071627C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DBD6E3A-5EFF-D3CC-92A1-746C9692ED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8B66E50-8662-DFD0-E6B5-A1111733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24EFA5D-B5C1-5B8B-E769-9134DA4E5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C67EF2B-78D6-B1A5-E3ED-C606A460D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647357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CE3C01-F52D-7A6E-1709-AF35BF34E6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D9931AB-75C5-F723-CF50-A704821B2D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CA8F727-527A-E14A-A227-26BEF50BC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504870A-4F70-F82E-CACD-0A6954B8A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2963181-4187-2419-3C94-39FF38B10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2328476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BAB2DA-7F5D-0546-C0BF-DC801DCF18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A53DD90-39EF-838F-98B0-C4E672D5AB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0814605-C1DB-C0C8-E72A-4F3DFC409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691A8F5-ADC9-5946-C15E-6754EF11B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498880-2FFF-9094-697F-B3D156D6B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476420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3E3637B-562F-C4AC-E32F-05A774D31A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803CD45-4408-0BEF-166C-1CF3A52D51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1D6142F-2416-A9BC-E20B-6B496A3875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8E90EA5-B08C-38F3-4BB5-3ED5FD816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31FDFD1-1B78-1739-A676-16BCD5676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0978226-4385-2492-A49D-9EA91E9BD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418573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4B876A-414A-E105-7A52-D1725BC09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3EBA3CD-1A1B-21A2-0F6E-78B4F56247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6244E10-B3C6-538B-E573-6A2FFA0D09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A29A057-79AC-0192-9098-44965DF533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72E9DF7A-DE27-F6A4-05CE-57407F6C2B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19BBA4F3-9841-A024-3CAA-624CA6785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39E6D9E-2109-A88B-C0A9-7D2527F97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F64CA4F-9BE4-EFDE-E1CD-39534721A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4258873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A406A68-B205-4845-7CC0-B1BFBF9BF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767A25A-E359-E451-8D26-C85C328A1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426CAE8-351E-8061-AA65-4A8B0D174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1250507-0100-30B9-036D-641F49CF1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2440477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E91FEC85-25BD-2F9A-D0B2-45D466632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9BFE847-6062-43D0-F5BA-AF0B31BE3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41A6717-F80A-926F-F279-4CE5554CA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939632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F21DF51-2D31-A88C-C178-63C133816C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ACBA8B8-8EC6-3DAF-2ECD-5E2D761B3D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7193C07-BC6A-EF4C-7152-DD9EBFA321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761FDC5-6E76-D1A5-A14B-56D5B5152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7D8CBFE-5748-0211-6408-04A6D5569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7DB55B5-724D-D378-61F8-CC5BE8BCE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238446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8B747DE-C69D-6228-1415-5AAAAFAFD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C8F4F03-FA96-BE91-78BF-5D116E39DA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 dirty="0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A1B932E-9CA3-A759-DD71-1ACE406054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70E5418-FEC3-A566-1E34-6525B291F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CAC4790-4BE1-9955-4123-889423E16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CBC2631-9604-E076-4FFD-C45497173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2433315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5CAD78B9-EFC1-6FAB-399B-75A7586DD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642626C-A0E6-7524-9265-A80FA16C17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E3A30CE-96A9-57A2-82B3-9E690B5A03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151094-384C-4BDC-B7FE-146D2F4AB4AF}" type="datetimeFigureOut">
              <a:rPr lang="es-CL" smtClean="0"/>
              <a:t>23-03-26</a:t>
            </a:fld>
            <a:endParaRPr lang="es-CL" dirty="0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C226E68-F783-DEFE-7AA2-36C16B9B17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 dirty="0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677E014-0ADD-6CCC-D96A-A7B648DF59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76997-B641-4659-AF6D-F8DFDC589118}" type="slidenum">
              <a:rPr lang="es-CL" smtClean="0"/>
              <a:t>‹#›</a:t>
            </a:fld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2781186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1CC94E-D905-2F1D-A736-7DD2C07BBF46}"/>
              </a:ext>
            </a:extLst>
          </p:cNvPr>
          <p:cNvSpPr txBox="1"/>
          <p:nvPr/>
        </p:nvSpPr>
        <p:spPr>
          <a:xfrm>
            <a:off x="0" y="31959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L" sz="1400" b="1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CL" sz="1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26562FA-B931-484E-FD9D-653791BDFDE8}"/>
              </a:ext>
            </a:extLst>
          </p:cNvPr>
          <p:cNvSpPr txBox="1"/>
          <p:nvPr/>
        </p:nvSpPr>
        <p:spPr>
          <a:xfrm>
            <a:off x="0" y="60090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CL" sz="1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BB2604EE-2114-80D3-264C-B7DB45315A44}"/>
              </a:ext>
            </a:extLst>
          </p:cNvPr>
          <p:cNvGrpSpPr/>
          <p:nvPr/>
        </p:nvGrpSpPr>
        <p:grpSpPr>
          <a:xfrm>
            <a:off x="213470" y="1243184"/>
            <a:ext cx="4775220" cy="3710781"/>
            <a:chOff x="564002" y="1361854"/>
            <a:chExt cx="3812990" cy="2994229"/>
          </a:xfrm>
        </p:grpSpPr>
        <p:pic>
          <p:nvPicPr>
            <p:cNvPr id="3" name="Picture 2" descr="A collage of different colored shapes&#10;&#10;Description automatically generated">
              <a:extLst>
                <a:ext uri="{FF2B5EF4-FFF2-40B4-BE49-F238E27FC236}">
                  <a16:creationId xmlns:a16="http://schemas.microsoft.com/office/drawing/2014/main" id="{3DCCA09A-07EA-B881-ACC0-50047A370BB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4002" y="1361854"/>
              <a:ext cx="3782881" cy="2561242"/>
            </a:xfrm>
            <a:prstGeom prst="rect">
              <a:avLst/>
            </a:prstGeom>
          </p:spPr>
        </p:pic>
        <p:pic>
          <p:nvPicPr>
            <p:cNvPr id="14" name="Imagen 13">
              <a:extLst>
                <a:ext uri="{FF2B5EF4-FFF2-40B4-BE49-F238E27FC236}">
                  <a16:creationId xmlns:a16="http://schemas.microsoft.com/office/drawing/2014/main" id="{D45B236E-3675-DB85-8EE3-A57C228EC7B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34891" y="2709381"/>
              <a:ext cx="3386940" cy="1085665"/>
            </a:xfrm>
            <a:prstGeom prst="rect">
              <a:avLst/>
            </a:prstGeom>
          </p:spPr>
        </p:pic>
        <p:sp>
          <p:nvSpPr>
            <p:cNvPr id="15" name="Rectángulo 14">
              <a:extLst>
                <a:ext uri="{FF2B5EF4-FFF2-40B4-BE49-F238E27FC236}">
                  <a16:creationId xmlns:a16="http://schemas.microsoft.com/office/drawing/2014/main" id="{3433E6DD-C9DF-8AB0-6F62-89B03041427C}"/>
                </a:ext>
              </a:extLst>
            </p:cNvPr>
            <p:cNvSpPr/>
            <p:nvPr/>
          </p:nvSpPr>
          <p:spPr>
            <a:xfrm>
              <a:off x="2811734" y="4225454"/>
              <a:ext cx="217714" cy="130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1F726F7F-D850-6A2C-B087-D417806D1E66}"/>
                </a:ext>
              </a:extLst>
            </p:cNvPr>
            <p:cNvSpPr txBox="1"/>
            <p:nvPr/>
          </p:nvSpPr>
          <p:spPr>
            <a:xfrm>
              <a:off x="1609190" y="3141698"/>
              <a:ext cx="565079" cy="173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2,85%</a:t>
              </a:r>
              <a:endParaRPr lang="es-CL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A16A8A8A-8A22-2E4D-6AFC-962C09517182}"/>
                </a:ext>
              </a:extLst>
            </p:cNvPr>
            <p:cNvSpPr txBox="1"/>
            <p:nvPr/>
          </p:nvSpPr>
          <p:spPr>
            <a:xfrm>
              <a:off x="2745385" y="3202744"/>
              <a:ext cx="460793" cy="173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,08%</a:t>
              </a:r>
              <a:endParaRPr lang="es-CL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AD36544A-46EA-79D2-C167-736609AB9F4D}"/>
                </a:ext>
              </a:extLst>
            </p:cNvPr>
            <p:cNvSpPr txBox="1"/>
            <p:nvPr/>
          </p:nvSpPr>
          <p:spPr>
            <a:xfrm>
              <a:off x="3916199" y="3111734"/>
              <a:ext cx="460793" cy="1738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46,5%</a:t>
              </a:r>
              <a:endParaRPr lang="es-CL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9BAAD94E-1757-FD4C-D746-F35DBB1BBD82}"/>
                </a:ext>
              </a:extLst>
            </p:cNvPr>
            <p:cNvSpPr/>
            <p:nvPr/>
          </p:nvSpPr>
          <p:spPr>
            <a:xfrm>
              <a:off x="3591426" y="2793053"/>
              <a:ext cx="460793" cy="14870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 dirty="0"/>
            </a:p>
          </p:txBody>
        </p:sp>
        <p:sp>
          <p:nvSpPr>
            <p:cNvPr id="19" name="Rectángulo 18">
              <a:extLst>
                <a:ext uri="{FF2B5EF4-FFF2-40B4-BE49-F238E27FC236}">
                  <a16:creationId xmlns:a16="http://schemas.microsoft.com/office/drawing/2014/main" id="{6E116CD4-20CC-3B66-2E7B-97D0D0172CC9}"/>
                </a:ext>
              </a:extLst>
            </p:cNvPr>
            <p:cNvSpPr/>
            <p:nvPr/>
          </p:nvSpPr>
          <p:spPr>
            <a:xfrm>
              <a:off x="2404905" y="2897116"/>
              <a:ext cx="460793" cy="2154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 dirty="0"/>
            </a:p>
          </p:txBody>
        </p:sp>
        <p:sp>
          <p:nvSpPr>
            <p:cNvPr id="20" name="Rectángulo 19">
              <a:extLst>
                <a:ext uri="{FF2B5EF4-FFF2-40B4-BE49-F238E27FC236}">
                  <a16:creationId xmlns:a16="http://schemas.microsoft.com/office/drawing/2014/main" id="{E939B228-0702-FEE8-5B2C-7D33FA2B3F5F}"/>
                </a:ext>
              </a:extLst>
            </p:cNvPr>
            <p:cNvSpPr/>
            <p:nvPr/>
          </p:nvSpPr>
          <p:spPr>
            <a:xfrm>
              <a:off x="1176093" y="2935062"/>
              <a:ext cx="460793" cy="1656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L" dirty="0"/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F73D9699-0B64-C92C-8F63-EE0907E7EFAF}"/>
              </a:ext>
            </a:extLst>
          </p:cNvPr>
          <p:cNvSpPr txBox="1"/>
          <p:nvPr/>
        </p:nvSpPr>
        <p:spPr>
          <a:xfrm>
            <a:off x="677955" y="926235"/>
            <a:ext cx="30582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henotype at day 0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ulture</a:t>
            </a:r>
          </a:p>
        </p:txBody>
      </p:sp>
    </p:spTree>
    <p:extLst>
      <p:ext uri="{BB962C8B-B14F-4D97-AF65-F5344CB8AC3E}">
        <p14:creationId xmlns:p14="http://schemas.microsoft.com/office/powerpoint/2010/main" val="31942906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9871EF-1EB7-3D1A-AC22-E7DEE558E7A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3C16593-366C-9BA1-87BC-09DD5D3A576B}"/>
              </a:ext>
            </a:extLst>
          </p:cNvPr>
          <p:cNvSpPr txBox="1"/>
          <p:nvPr/>
        </p:nvSpPr>
        <p:spPr>
          <a:xfrm>
            <a:off x="0" y="31959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L" sz="1400" b="1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CL" sz="1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0F0F116-459E-7C9F-3102-C2B1ED64F592}"/>
              </a:ext>
            </a:extLst>
          </p:cNvPr>
          <p:cNvSpPr txBox="1"/>
          <p:nvPr/>
        </p:nvSpPr>
        <p:spPr>
          <a:xfrm>
            <a:off x="270955" y="38566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CL" sz="1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732F407-3DD6-C25D-8CEB-5A6E232D0AA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17"/>
          <a:stretch/>
        </p:blipFill>
        <p:spPr>
          <a:xfrm>
            <a:off x="505952" y="942313"/>
            <a:ext cx="7407873" cy="2671200"/>
          </a:xfrm>
          <a:prstGeom prst="rect">
            <a:avLst/>
          </a:prstGeom>
        </p:spPr>
      </p:pic>
      <p:pic>
        <p:nvPicPr>
          <p:cNvPr id="7" name="Picture 6" descr="A white background with black spots&#10;&#10;Description automatically generated">
            <a:extLst>
              <a:ext uri="{FF2B5EF4-FFF2-40B4-BE49-F238E27FC236}">
                <a16:creationId xmlns:a16="http://schemas.microsoft.com/office/drawing/2014/main" id="{466956C3-49A8-C5A4-434E-F1549E69EC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309" y="3842008"/>
            <a:ext cx="6096000" cy="27209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763D2D5-C38D-7D9A-6D01-9FF66BB87F92}"/>
              </a:ext>
            </a:extLst>
          </p:cNvPr>
          <p:cNvSpPr txBox="1"/>
          <p:nvPr/>
        </p:nvSpPr>
        <p:spPr>
          <a:xfrm>
            <a:off x="270955" y="3553321"/>
            <a:ext cx="2327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CL" sz="16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51AC7C8B-E3E1-8D76-44E7-D83AFFFC08DA}"/>
              </a:ext>
            </a:extLst>
          </p:cNvPr>
          <p:cNvSpPr/>
          <p:nvPr/>
        </p:nvSpPr>
        <p:spPr>
          <a:xfrm>
            <a:off x="2587690" y="2382416"/>
            <a:ext cx="217714" cy="13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65C6CB08-6FAA-B68C-0082-38E16CA09759}"/>
              </a:ext>
            </a:extLst>
          </p:cNvPr>
          <p:cNvSpPr/>
          <p:nvPr/>
        </p:nvSpPr>
        <p:spPr>
          <a:xfrm>
            <a:off x="1445387" y="2404187"/>
            <a:ext cx="217714" cy="1306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09ED0AC2-2C17-90B8-DCCB-CA6A1C28D5EF}"/>
              </a:ext>
            </a:extLst>
          </p:cNvPr>
          <p:cNvSpPr/>
          <p:nvPr/>
        </p:nvSpPr>
        <p:spPr>
          <a:xfrm>
            <a:off x="3435309" y="2054268"/>
            <a:ext cx="460793" cy="1002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id="{DAAF41FF-1F19-8FF8-EC76-39836CC3311A}"/>
              </a:ext>
            </a:extLst>
          </p:cNvPr>
          <p:cNvSpPr/>
          <p:nvPr/>
        </p:nvSpPr>
        <p:spPr>
          <a:xfrm>
            <a:off x="2248788" y="2116531"/>
            <a:ext cx="460793" cy="2154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  <p:sp>
        <p:nvSpPr>
          <p:cNvPr id="20" name="Rectángulo 19">
            <a:extLst>
              <a:ext uri="{FF2B5EF4-FFF2-40B4-BE49-F238E27FC236}">
                <a16:creationId xmlns:a16="http://schemas.microsoft.com/office/drawing/2014/main" id="{AA60828D-F803-037A-A5B6-B6E762A17100}"/>
              </a:ext>
            </a:extLst>
          </p:cNvPr>
          <p:cNvSpPr/>
          <p:nvPr/>
        </p:nvSpPr>
        <p:spPr>
          <a:xfrm>
            <a:off x="1019976" y="2204214"/>
            <a:ext cx="460793" cy="1002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8326830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D3AD465-FF84-FD5E-F553-A52E8A172A6D}"/>
              </a:ext>
            </a:extLst>
          </p:cNvPr>
          <p:cNvSpPr txBox="1"/>
          <p:nvPr/>
        </p:nvSpPr>
        <p:spPr>
          <a:xfrm>
            <a:off x="189063" y="218025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L" sz="1400" b="1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CL" sz="1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5854F9C-FD6E-3649-D7DF-C5777813D6EF}"/>
              </a:ext>
            </a:extLst>
          </p:cNvPr>
          <p:cNvSpPr txBox="1"/>
          <p:nvPr/>
        </p:nvSpPr>
        <p:spPr>
          <a:xfrm>
            <a:off x="189063" y="124171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L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9" name="Picture 18" descr="A graph of a number of different sizes and shapes&#10;&#10;Description automatically generated with medium confidence">
            <a:extLst>
              <a:ext uri="{FF2B5EF4-FFF2-40B4-BE49-F238E27FC236}">
                <a16:creationId xmlns:a16="http://schemas.microsoft.com/office/drawing/2014/main" id="{DD996B50-290E-48E7-D5C2-D941E17CD9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504" y="1349697"/>
            <a:ext cx="2150747" cy="253523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2BBAC80-0C54-3B23-985E-E510B03A82C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1426" y="1368567"/>
            <a:ext cx="2173383" cy="2525495"/>
          </a:xfrm>
          <a:prstGeom prst="rect">
            <a:avLst/>
          </a:prstGeom>
        </p:spPr>
      </p:pic>
      <p:pic>
        <p:nvPicPr>
          <p:cNvPr id="22" name="Picture 21" descr="A graph of a bar graph&#10;&#10;Description automatically generated with medium confidence">
            <a:extLst>
              <a:ext uri="{FF2B5EF4-FFF2-40B4-BE49-F238E27FC236}">
                <a16:creationId xmlns:a16="http://schemas.microsoft.com/office/drawing/2014/main" id="{839CFEB5-91B5-5565-3D46-F4D4E61059B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4574" y="1299308"/>
            <a:ext cx="2173384" cy="2605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01220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1CC94E-D905-2F1D-A736-7DD2C07BBF46}"/>
              </a:ext>
            </a:extLst>
          </p:cNvPr>
          <p:cNvSpPr txBox="1"/>
          <p:nvPr/>
        </p:nvSpPr>
        <p:spPr>
          <a:xfrm>
            <a:off x="36913" y="92246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L" sz="1400" b="1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CL" sz="1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166BC42-5885-9101-0966-25CFD702BADA}"/>
              </a:ext>
            </a:extLst>
          </p:cNvPr>
          <p:cNvSpPr txBox="1"/>
          <p:nvPr/>
        </p:nvSpPr>
        <p:spPr>
          <a:xfrm>
            <a:off x="6355830" y="638581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CL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60FEE273-9249-191C-2B93-E842DE4960A4}"/>
              </a:ext>
            </a:extLst>
          </p:cNvPr>
          <p:cNvSpPr txBox="1"/>
          <p:nvPr/>
        </p:nvSpPr>
        <p:spPr>
          <a:xfrm>
            <a:off x="-26025" y="80306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C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61A8D8D-2281-F3AF-C663-954418D13402}"/>
              </a:ext>
            </a:extLst>
          </p:cNvPr>
          <p:cNvSpPr txBox="1"/>
          <p:nvPr/>
        </p:nvSpPr>
        <p:spPr>
          <a:xfrm>
            <a:off x="2481240" y="80306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C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5186CADC-3714-7924-315A-2B7D519638C3}"/>
              </a:ext>
            </a:extLst>
          </p:cNvPr>
          <p:cNvSpPr txBox="1"/>
          <p:nvPr/>
        </p:nvSpPr>
        <p:spPr>
          <a:xfrm>
            <a:off x="5161905" y="8030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s-C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9CF0072-6D9C-5B87-802F-688A925C2C4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8431" r="28431"/>
          <a:stretch>
            <a:fillRect/>
          </a:stretch>
        </p:blipFill>
        <p:spPr>
          <a:xfrm rot="5400000">
            <a:off x="2589164" y="-1538055"/>
            <a:ext cx="2615189" cy="7845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46499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FB8C61EC-261C-E7A2-AA48-F97457BB9FBA}"/>
              </a:ext>
            </a:extLst>
          </p:cNvPr>
          <p:cNvSpPr txBox="1"/>
          <p:nvPr/>
        </p:nvSpPr>
        <p:spPr>
          <a:xfrm>
            <a:off x="0" y="42097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573EF432-BBFB-D534-263D-CF52560B8A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9075" y="790305"/>
            <a:ext cx="4193030" cy="402734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705EB65-FC86-EB68-C097-E4EE69C2C5CC}"/>
              </a:ext>
            </a:extLst>
          </p:cNvPr>
          <p:cNvSpPr txBox="1"/>
          <p:nvPr/>
        </p:nvSpPr>
        <p:spPr>
          <a:xfrm>
            <a:off x="-27482" y="-36544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L" sz="1400" b="1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r>
              <a:rPr lang="en-CL" sz="1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A89A089-5719-D30E-568A-D3FDD13B04B8}"/>
              </a:ext>
            </a:extLst>
          </p:cNvPr>
          <p:cNvSpPr/>
          <p:nvPr/>
        </p:nvSpPr>
        <p:spPr>
          <a:xfrm>
            <a:off x="10776866" y="2886891"/>
            <a:ext cx="352688" cy="1694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93628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CB50E8F-AE21-1105-1E4D-2F0CFCD0FF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1746F0D-F119-F5A3-D8DC-66C510272FBC}"/>
              </a:ext>
            </a:extLst>
          </p:cNvPr>
          <p:cNvGrpSpPr/>
          <p:nvPr/>
        </p:nvGrpSpPr>
        <p:grpSpPr>
          <a:xfrm>
            <a:off x="-27482" y="-36544"/>
            <a:ext cx="11157036" cy="5939353"/>
            <a:chOff x="-27482" y="-36544"/>
            <a:chExt cx="11157036" cy="5939353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D4996E6-5637-22D2-B303-CEAA7A09401F}"/>
                </a:ext>
              </a:extLst>
            </p:cNvPr>
            <p:cNvSpPr txBox="1"/>
            <p:nvPr/>
          </p:nvSpPr>
          <p:spPr>
            <a:xfrm>
              <a:off x="-27482" y="-36544"/>
              <a:ext cx="22733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L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6</a:t>
              </a:r>
              <a:r>
                <a:rPr lang="en-CL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1D71CA82-413F-C750-B5C5-F6587CAD32CB}"/>
                </a:ext>
              </a:extLst>
            </p:cNvPr>
            <p:cNvGrpSpPr/>
            <p:nvPr/>
          </p:nvGrpSpPr>
          <p:grpSpPr>
            <a:xfrm>
              <a:off x="0" y="501650"/>
              <a:ext cx="11129554" cy="5401159"/>
              <a:chOff x="0" y="501650"/>
              <a:chExt cx="11129554" cy="5401159"/>
            </a:xfrm>
          </p:grpSpPr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31C04413-1D9A-4121-01D4-9AD8299B84FD}"/>
                  </a:ext>
                </a:extLst>
              </p:cNvPr>
              <p:cNvSpPr/>
              <p:nvPr/>
            </p:nvSpPr>
            <p:spPr>
              <a:xfrm>
                <a:off x="10776866" y="2886891"/>
                <a:ext cx="352688" cy="16948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97558567-C1C3-E27C-F642-D2AE0C3AE7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0" y="501650"/>
                <a:ext cx="7772400" cy="5401159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3D94CE8-2A42-3EB6-D6D4-41F0D9C1E445}"/>
                  </a:ext>
                </a:extLst>
              </p:cNvPr>
              <p:cNvSpPr txBox="1"/>
              <p:nvPr/>
            </p:nvSpPr>
            <p:spPr>
              <a:xfrm>
                <a:off x="2731171" y="1143000"/>
                <a:ext cx="112402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On lymphocyte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E6F28AB-12A7-5A41-AC7F-15F7EA5533BE}"/>
                  </a:ext>
                </a:extLst>
              </p:cNvPr>
              <p:cNvSpPr txBox="1"/>
              <p:nvPr/>
            </p:nvSpPr>
            <p:spPr>
              <a:xfrm>
                <a:off x="4724405" y="1143000"/>
                <a:ext cx="86914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On CD4+ T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7B9AB21-369E-B84B-60DA-B12DDF5AEB5C}"/>
                  </a:ext>
                </a:extLst>
              </p:cNvPr>
              <p:cNvSpPr txBox="1"/>
              <p:nvPr/>
            </p:nvSpPr>
            <p:spPr>
              <a:xfrm>
                <a:off x="2955759" y="3923670"/>
                <a:ext cx="112402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On lymphocyte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79D70EC-1F69-915A-A41A-9A9D58BA6096}"/>
                  </a:ext>
                </a:extLst>
              </p:cNvPr>
              <p:cNvSpPr txBox="1"/>
              <p:nvPr/>
            </p:nvSpPr>
            <p:spPr>
              <a:xfrm>
                <a:off x="5001631" y="3931364"/>
                <a:ext cx="91242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On live cells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C7EEA6A-973D-B790-52F9-537D77F6F204}"/>
                  </a:ext>
                </a:extLst>
              </p:cNvPr>
              <p:cNvSpPr txBox="1"/>
              <p:nvPr/>
            </p:nvSpPr>
            <p:spPr>
              <a:xfrm>
                <a:off x="6912941" y="3917028"/>
                <a:ext cx="86914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On CD4+ T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32459750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60</TotalTime>
  <Words>61</Words>
  <Application>Microsoft Macintosh PowerPoint</Application>
  <PresentationFormat>Widescreen</PresentationFormat>
  <Paragraphs>29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1_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Padilla Ruiz</dc:creator>
  <cp:lastModifiedBy>Karina De Las Mercedes Pino Lagos</cp:lastModifiedBy>
  <cp:revision>109</cp:revision>
  <cp:lastPrinted>2024-12-10T18:39:53Z</cp:lastPrinted>
  <dcterms:created xsi:type="dcterms:W3CDTF">2024-09-13T19:39:36Z</dcterms:created>
  <dcterms:modified xsi:type="dcterms:W3CDTF">2026-03-23T15:29:23Z</dcterms:modified>
</cp:coreProperties>
</file>